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gif" ContentType="image/gif"/>
  <Override PartName="/ppt/media/image2.gif" ContentType="image/gi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FFB0B7-0F8E-4CA8-9E53-C79118D356F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C26080-72C1-4DC0-8F0C-A8F06FE58DA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96FF7C-6EE6-4F2E-BEB4-A2BE50E1693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5C0438-1CA0-42DA-AC6D-6EB3C9A37EA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8C6646-234E-45A6-BA39-8836A85A2C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A5AF34-A4DB-45D8-8260-27E2217BF5F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9EF605-DB8B-413B-B981-0E59897E0B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BDFC7A-44B2-4A06-A3BA-FA5E9D5A27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43B093-1450-4D37-B9B2-8C8A84A4DD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E18467-34B5-4644-A688-E79C3F4B12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3D6EE2-33AF-4DDD-BFD3-8980DDFF6B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496AD5-2C51-4D90-8319-594AE5AE54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94F0AC3-0A42-4196-B539-EF00FC11B1A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gif"/><Relationship Id="rId2" Type="http://schemas.openxmlformats.org/officeDocument/2006/relationships/image" Target="../media/image2.gi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4400" spc="-1" strike="noStrike">
                <a:solidFill>
                  <a:srgbClr val="000000"/>
                </a:solidFill>
                <a:latin typeface="Calibri"/>
              </a:rPr>
              <a:t>Cinematographic MRI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/>
          </p:nvPr>
        </p:nvSpPr>
        <p:spPr>
          <a:xfrm>
            <a:off x="456840" y="1534680"/>
            <a:ext cx="4040280" cy="63972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rmAutofit/>
          </a:bodyPr>
          <a:p>
            <a:pPr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2400" spc="-1" strike="noStrike">
                <a:solidFill>
                  <a:srgbClr val="000000"/>
                </a:solidFill>
                <a:latin typeface="Calibri"/>
              </a:rPr>
              <a:t>Short axis orientation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/>
          </p:nvPr>
        </p:nvSpPr>
        <p:spPr>
          <a:xfrm>
            <a:off x="4644720" y="1534680"/>
            <a:ext cx="4041720" cy="63972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rmAutofit/>
          </a:bodyPr>
          <a:p>
            <a:pPr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2400" spc="-1" strike="noStrike">
                <a:solidFill>
                  <a:srgbClr val="000000"/>
                </a:solidFill>
                <a:latin typeface="Calibri"/>
              </a:rPr>
              <a:t>Long axis orientation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itle 1"/>
          <p:cNvSpPr/>
          <p:nvPr/>
        </p:nvSpPr>
        <p:spPr>
          <a:xfrm>
            <a:off x="0" y="1125360"/>
            <a:ext cx="9144000" cy="444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2800" spc="-1" strike="noStrike">
                <a:solidFill>
                  <a:srgbClr val="000000"/>
                </a:solidFill>
                <a:latin typeface="Calibri"/>
              </a:rPr>
              <a:t>Severe TAC mouse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10"/>
          <p:cNvSpPr/>
          <p:nvPr/>
        </p:nvSpPr>
        <p:spPr>
          <a:xfrm>
            <a:off x="0" y="6156360"/>
            <a:ext cx="91440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Figure S3.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Representative end diastolic short-axis and long-axis images from a severe TAC mouse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Picture 11" descr="B:\Publications\articles\2011-04; Cardiovascular Research - mild versus severe TAC (in prep)\02_rebuttal Cardiovascular Research\Supplementary material\sTAC\sTAC_Cine_SA.gif"/>
          <p:cNvPicPr/>
          <p:nvPr/>
        </p:nvPicPr>
        <p:blipFill>
          <a:blip r:embed="rId1"/>
          <a:stretch/>
        </p:blipFill>
        <p:spPr>
          <a:xfrm flipH="1">
            <a:off x="501480" y="2174760"/>
            <a:ext cx="3951360" cy="395136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12" descr="B:\Publications\articles\2011-04; Cardiovascular Research - mild versus severe TAC (in prep)\02_rebuttal Cardiovascular Research\Supplementary material\sTAC\sTAC_Cine_LA.gif"/>
          <p:cNvPicPr/>
          <p:nvPr/>
        </p:nvPicPr>
        <p:blipFill>
          <a:blip r:embed="rId2"/>
          <a:stretch/>
        </p:blipFill>
        <p:spPr>
          <a:xfrm flipH="1">
            <a:off x="4689360" y="2174760"/>
            <a:ext cx="3951360" cy="3951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8-22T11:30:18Z</dcterms:created>
  <dc:creator>B.J van Nierop</dc:creator>
  <dc:description/>
  <dc:language>en-US</dc:language>
  <cp:lastModifiedBy>B.J van Nierop</cp:lastModifiedBy>
  <dcterms:modified xsi:type="dcterms:W3CDTF">2013-01-06T12:23:49Z</dcterms:modified>
  <cp:revision>8</cp:revision>
  <dc:subject/>
  <dc:title>Cinematographic MRI</dc:title>
</cp:coreProperties>
</file>